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BD641A-164C-413E-AA0D-2D294DA10DD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3518AA-A1CC-4CC9-93E6-B06A7D53681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4BFD06-05D3-4D19-9C26-9C8E7645CEE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62F8B5-3004-430D-9941-208D1E5D44A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85A1D9-0553-4BDB-988F-D507DE1A4C3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1A608D-A738-490E-AD29-E0B7830E65F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0B0644-A744-4302-BCA0-91DF2AD157F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0969E1-0518-4407-8D90-E69FE133578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684B01-5A08-4889-A07F-8720947A41C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DD1B47-BC11-4C90-BA11-1BA102EFDE8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3589CB-E813-484C-833A-674E4C1140B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2EF49A-8ED2-40AC-8CF1-3FE4EBABA75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1964196-BC39-426D-8DF1-68DBCD37C6E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1143000" y="587520"/>
            <a:ext cx="6781680" cy="482256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228600" y="5486400"/>
            <a:ext cx="8601120" cy="10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T-test sliding window whole genome and chromosome 2 analysis.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. 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-test sliding window whole genome scan (window size = 40 adjacent genes, step size = 1).  The T score is given on the Y axis and the chromosomes are on the X axis. Each dot in the chromosome peaks represents a window score.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Detailed T-test sliding window plot of chromosome 2, with T-score on the Y axis and location on chromosome 2 from the centromere to the end of the q arm on the X axis.  The highest differential peak of expression is in band H4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2-20T20:33:13Z</dcterms:created>
  <dc:creator>bdavi1</dc:creator>
  <dc:description/>
  <dc:language>en-US</dc:language>
  <cp:lastModifiedBy>ktsuch</cp:lastModifiedBy>
  <dcterms:modified xsi:type="dcterms:W3CDTF">2009-09-24T00:06:23Z</dcterms:modified>
  <cp:revision>10</cp:revision>
  <dc:subject/>
  <dc:title>Slide 1</dc:title>
</cp:coreProperties>
</file>